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44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6E1E15-57FB-4409-8996-B9051F6FF842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365CDA-F963-4676-A47B-D43250655A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24687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7B0F41-FA9F-4A32-AB8D-AD447549106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3692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39FE50-239F-5F7F-A575-AF04ECF9ED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9427094-1D40-A256-183F-FEDC597CA43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410FCB-D062-08D0-440D-AB59858991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1232A-53F1-4D9E-83D1-CE181B86FACC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70276A-6002-F881-7971-673CBAEBDC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6BB638-EE24-631C-A50E-F0A617160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3084D-5809-46B9-8DC7-A235AC54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1368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ED63C2-2484-B13E-142A-22BA3A8354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E49102D-F703-A2C9-20E6-04CE42D2FE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47697B-C4C6-C3F8-65FC-764BDC3C2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1232A-53F1-4D9E-83D1-CE181B86FACC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C4A66E-0DD1-2178-0C1C-1F136BF97D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109AB1-DDB1-0809-4DE3-84AADFC90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3084D-5809-46B9-8DC7-A235AC54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9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370912C-F34D-3EFE-DCAC-06E5C5E5FF2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16A2EA-333F-6B3E-F3FD-01FD79573C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ADC4DF-EEBD-10B6-2CE5-E353CDE4E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1232A-53F1-4D9E-83D1-CE181B86FACC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0AC479-C61D-8541-614F-08BE2D1701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910F64-CCCC-DBCA-39F2-0BCC428E22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3084D-5809-46B9-8DC7-A235AC54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995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4F393E-3117-2542-A69E-EACE1C97E7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555BDA-40DF-B8FA-8ECE-9B7CE42B0F5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7A66E2-2397-AAE7-B06A-7C95489B9C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1232A-53F1-4D9E-83D1-CE181B86FACC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B588BB-2716-EF55-19FA-AFBDF8AD3F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022EC1-BE4F-7767-7D83-3B0AD70D0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3084D-5809-46B9-8DC7-A235AC54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9488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A31DDE-74B0-723A-1097-D5DB2724CF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0C6FA7-6EAE-220C-55D5-565690C804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591346-FBFE-D3C0-C6D8-2EEE76114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1232A-53F1-4D9E-83D1-CE181B86FACC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D453E9-E535-AD65-1A9D-B519BF0AC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6FABF3-CC9E-69C0-B3E8-CD0B3F431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3084D-5809-46B9-8DC7-A235AC54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117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5719BE-76FE-A783-6579-5BDA779EBE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2AA8CE-E6FD-67AA-784A-D0EE33C703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71AB0B5-B9F6-80DD-ECC7-1D26E63B2F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0A9937-D198-B479-6FCA-605DEA6280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1232A-53F1-4D9E-83D1-CE181B86FACC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59A2F5-6088-6712-88BE-CCDB5957CD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FDA311D-F78F-2E59-B8C0-58C87FBD9B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3084D-5809-46B9-8DC7-A235AC54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464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432C90-C3C5-266F-74E6-1B1267038E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866394-4BD8-EC7A-DE68-B9A205F5C5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E011DD-4508-64D9-F53A-980FA7C813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6263B9B-7279-2A26-C29B-2F4885D6DAD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26F87E4-D915-5CD5-4F88-C594F3BA47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3CF720B-DE82-761D-AE36-147A76144A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1232A-53F1-4D9E-83D1-CE181B86FACC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504F7D7-249F-8089-F047-DF99D5225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FE42BA-A7B0-98A1-8529-D3569EE3B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3084D-5809-46B9-8DC7-A235AC54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390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C4855A-4CAD-89CA-83F7-6B2EA2D940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9DD87C9-7BC7-3104-6321-DBBDF17026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1232A-53F1-4D9E-83D1-CE181B86FACC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D206396-63A4-505F-71EA-3A7A62C9F8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53796E5-5E86-273D-91C4-8306DA51B7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3084D-5809-46B9-8DC7-A235AC54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417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5B60C56-0FA6-E3E1-F469-D431051B08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1232A-53F1-4D9E-83D1-CE181B86FACC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B43212-331D-3658-4353-6D8844AE3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0FA3702-65A1-35DD-6D81-897163E34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3084D-5809-46B9-8DC7-A235AC54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075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670047-24A0-7CD1-ECC2-EEB11A545D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A3F3FE-8197-86CB-BC34-4F293D732A9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BA29CC-B80B-2EDD-CA5E-2D12AE00E0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0EABBD-0E7F-6BAC-2D3F-AFCA03DFC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1232A-53F1-4D9E-83D1-CE181B86FACC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EB3098-2954-A3EA-5C00-0011D7BD7E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E65B23C-4115-65F3-AA56-87AC1D1869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3084D-5809-46B9-8DC7-A235AC54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533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5A3BC0-2126-3342-F855-2C45EA7163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5AD093C-5617-8FF6-9FC9-5F498CFE7E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D03FED1-7A23-58AA-C4BD-CE91BDAC70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F48ACA-C009-2607-3E63-CCF939AF09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1232A-53F1-4D9E-83D1-CE181B86FACC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F1F749-7A6B-07F9-9D69-8489AA455F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92A4D1-FD93-05F3-86E9-179E665C6E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3084D-5809-46B9-8DC7-A235AC54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780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8C283C2-166A-3A45-638C-B6783A6D7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398B6C-1B8F-EC70-6C8F-9B6EE88D0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DC01D3-68CB-7DE8-C013-5852012F43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41232A-53F1-4D9E-83D1-CE181B86FACC}" type="datetimeFigureOut">
              <a:rPr lang="en-US" smtClean="0"/>
              <a:t>10/3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D5FDB4-EA5E-F6C2-90CC-BCBBE24A7A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98F8D5-C7D2-6F93-6026-AAEE4CBF1A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3084D-5809-46B9-8DC7-A235AC540C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9742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D4910C-6504-78E4-DFC7-7D2FBE7188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84909" y="599701"/>
            <a:ext cx="3023763" cy="1325563"/>
          </a:xfrm>
        </p:spPr>
        <p:txBody>
          <a:bodyPr>
            <a:normAutofit/>
          </a:bodyPr>
          <a:lstStyle/>
          <a:p>
            <a:r>
              <a:rPr lang="en-US" sz="3600" b="1" dirty="0">
                <a:latin typeface="Fira Sans" panose="020B0503050000020004" pitchFamily="34" charset="0"/>
              </a:rPr>
              <a:t>Participant selection</a:t>
            </a: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76C68DE4-8E2F-7437-B052-B8F829F03A3A}"/>
              </a:ext>
            </a:extLst>
          </p:cNvPr>
          <p:cNvSpPr/>
          <p:nvPr/>
        </p:nvSpPr>
        <p:spPr>
          <a:xfrm>
            <a:off x="4810991" y="362627"/>
            <a:ext cx="2202872" cy="872836"/>
          </a:xfrm>
          <a:prstGeom prst="roundRect">
            <a:avLst/>
          </a:prstGeom>
          <a:solidFill>
            <a:schemeClr val="bg1"/>
          </a:solidFill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n>
                <a:solidFill>
                  <a:srgbClr val="0070C0"/>
                </a:solidFill>
              </a:ln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0D74888-4BEE-FFDC-B80E-3FF87FB8BA6F}"/>
              </a:ext>
            </a:extLst>
          </p:cNvPr>
          <p:cNvSpPr txBox="1"/>
          <p:nvPr/>
        </p:nvSpPr>
        <p:spPr>
          <a:xfrm>
            <a:off x="4904507" y="501048"/>
            <a:ext cx="211974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All screening cases (n=1,625)</a:t>
            </a:r>
          </a:p>
        </p:txBody>
      </p: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81A77099-06EC-5821-CBE9-A26C6DC5C86F}"/>
              </a:ext>
            </a:extLst>
          </p:cNvPr>
          <p:cNvCxnSpPr>
            <a:cxnSpLocks/>
          </p:cNvCxnSpPr>
          <p:nvPr/>
        </p:nvCxnSpPr>
        <p:spPr>
          <a:xfrm>
            <a:off x="5811985" y="1235463"/>
            <a:ext cx="0" cy="72690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7606CBF5-43DE-7E7C-43E2-602CD1B15E04}"/>
              </a:ext>
            </a:extLst>
          </p:cNvPr>
          <p:cNvSpPr/>
          <p:nvPr/>
        </p:nvSpPr>
        <p:spPr>
          <a:xfrm>
            <a:off x="4790209" y="2022811"/>
            <a:ext cx="2202872" cy="872836"/>
          </a:xfrm>
          <a:prstGeom prst="roundRect">
            <a:avLst/>
          </a:prstGeom>
          <a:solidFill>
            <a:schemeClr val="bg1"/>
          </a:solidFill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err="1"/>
              <a:t>i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42D0578-0E23-6A60-5C97-231BDE23A3DA}"/>
              </a:ext>
            </a:extLst>
          </p:cNvPr>
          <p:cNvSpPr txBox="1"/>
          <p:nvPr/>
        </p:nvSpPr>
        <p:spPr>
          <a:xfrm>
            <a:off x="4895849" y="2073349"/>
            <a:ext cx="205047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Individuals with abnormal results (n=942)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93E8242A-E14F-B8C9-8E1A-282C1E51B415}"/>
              </a:ext>
            </a:extLst>
          </p:cNvPr>
          <p:cNvCxnSpPr>
            <a:cxnSpLocks/>
          </p:cNvCxnSpPr>
          <p:nvPr/>
        </p:nvCxnSpPr>
        <p:spPr>
          <a:xfrm>
            <a:off x="5811984" y="2904346"/>
            <a:ext cx="0" cy="885208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: Rounded Corners 11">
            <a:extLst>
              <a:ext uri="{FF2B5EF4-FFF2-40B4-BE49-F238E27FC236}">
                <a16:creationId xmlns:a16="http://schemas.microsoft.com/office/drawing/2014/main" id="{9D015140-5E28-49D2-0BD1-D974D3D1A9A7}"/>
              </a:ext>
            </a:extLst>
          </p:cNvPr>
          <p:cNvSpPr/>
          <p:nvPr/>
        </p:nvSpPr>
        <p:spPr>
          <a:xfrm>
            <a:off x="4790209" y="3846330"/>
            <a:ext cx="2202872" cy="872836"/>
          </a:xfrm>
          <a:prstGeom prst="roundRect">
            <a:avLst/>
          </a:prstGeom>
          <a:solidFill>
            <a:schemeClr val="bg1"/>
          </a:solidFill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err="1"/>
              <a:t>iF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5AC6AB6-F50D-DCFD-E420-D75F43400511}"/>
              </a:ext>
            </a:extLst>
          </p:cNvPr>
          <p:cNvSpPr txBox="1"/>
          <p:nvPr/>
        </p:nvSpPr>
        <p:spPr>
          <a:xfrm>
            <a:off x="4790209" y="3888285"/>
            <a:ext cx="225482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/>
              <a:t>Individuals eligible for nurse follow-up for 6 months (n=653)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823EA4A1-4AD4-CB69-FC1C-BDC0F83EECF9}"/>
              </a:ext>
            </a:extLst>
          </p:cNvPr>
          <p:cNvCxnSpPr>
            <a:cxnSpLocks/>
          </p:cNvCxnSpPr>
          <p:nvPr/>
        </p:nvCxnSpPr>
        <p:spPr>
          <a:xfrm>
            <a:off x="5811984" y="1589809"/>
            <a:ext cx="1946561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9474BC26-24A9-C901-9137-5A5D40D1405E}"/>
              </a:ext>
            </a:extLst>
          </p:cNvPr>
          <p:cNvCxnSpPr>
            <a:cxnSpLocks/>
          </p:cNvCxnSpPr>
          <p:nvPr/>
        </p:nvCxnSpPr>
        <p:spPr>
          <a:xfrm>
            <a:off x="5811984" y="3346950"/>
            <a:ext cx="1946561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: Rounded Corners 21">
            <a:extLst>
              <a:ext uri="{FF2B5EF4-FFF2-40B4-BE49-F238E27FC236}">
                <a16:creationId xmlns:a16="http://schemas.microsoft.com/office/drawing/2014/main" id="{44AE3396-E10D-65E4-CB82-9E765F00B97B}"/>
              </a:ext>
            </a:extLst>
          </p:cNvPr>
          <p:cNvSpPr/>
          <p:nvPr/>
        </p:nvSpPr>
        <p:spPr>
          <a:xfrm>
            <a:off x="7762007" y="1147379"/>
            <a:ext cx="3595251" cy="814984"/>
          </a:xfrm>
          <a:prstGeom prst="roundRect">
            <a:avLst/>
          </a:prstGeom>
          <a:solidFill>
            <a:schemeClr val="bg1"/>
          </a:solidFill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err="1"/>
              <a:t>Ecl</a:t>
            </a:r>
            <a:endParaRPr lang="en-US" dirty="0"/>
          </a:p>
        </p:txBody>
      </p:sp>
      <p:sp>
        <p:nvSpPr>
          <p:cNvPr id="23" name="Rectangle: Rounded Corners 22">
            <a:extLst>
              <a:ext uri="{FF2B5EF4-FFF2-40B4-BE49-F238E27FC236}">
                <a16:creationId xmlns:a16="http://schemas.microsoft.com/office/drawing/2014/main" id="{F7A89C13-533B-1390-CA1F-6AB88EE3A5E1}"/>
              </a:ext>
            </a:extLst>
          </p:cNvPr>
          <p:cNvSpPr/>
          <p:nvPr/>
        </p:nvSpPr>
        <p:spPr>
          <a:xfrm>
            <a:off x="7762008" y="2774373"/>
            <a:ext cx="3595250" cy="1015182"/>
          </a:xfrm>
          <a:prstGeom prst="roundRect">
            <a:avLst/>
          </a:prstGeom>
          <a:solidFill>
            <a:schemeClr val="bg1"/>
          </a:solidFill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C348F03-9D90-5FCD-009C-0F2C6FA07382}"/>
              </a:ext>
            </a:extLst>
          </p:cNvPr>
          <p:cNvSpPr txBox="1"/>
          <p:nvPr/>
        </p:nvSpPr>
        <p:spPr>
          <a:xfrm>
            <a:off x="7862456" y="1262483"/>
            <a:ext cx="35952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u="sng" dirty="0"/>
              <a:t>Excluded cases (n=683):</a:t>
            </a:r>
          </a:p>
          <a:p>
            <a:r>
              <a:rPr lang="en-US" sz="1400" dirty="0"/>
              <a:t>normal or at-risk results recorded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D2B1EC9-DC52-8863-2940-7B8969784AB7}"/>
              </a:ext>
            </a:extLst>
          </p:cNvPr>
          <p:cNvSpPr txBox="1"/>
          <p:nvPr/>
        </p:nvSpPr>
        <p:spPr>
          <a:xfrm>
            <a:off x="7862456" y="2774372"/>
            <a:ext cx="3252348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u="sng" dirty="0"/>
              <a:t>Excluded cases (n=289)</a:t>
            </a:r>
            <a:r>
              <a:rPr lang="en-US" sz="1200" dirty="0"/>
              <a:t>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/>
              <a:t>Condition previously diagnosed by a doctor &amp; on medication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200" dirty="0"/>
              <a:t>Did not receive referral recommendation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600" dirty="0"/>
          </a:p>
          <a:p>
            <a:endParaRPr lang="en-US" dirty="0"/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DC100C17-8655-4475-D41A-A9678A65DC23}"/>
              </a:ext>
            </a:extLst>
          </p:cNvPr>
          <p:cNvCxnSpPr>
            <a:cxnSpLocks/>
          </p:cNvCxnSpPr>
          <p:nvPr/>
        </p:nvCxnSpPr>
        <p:spPr>
          <a:xfrm>
            <a:off x="5796393" y="4719166"/>
            <a:ext cx="0" cy="809809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Rectangle: Rounded Corners 38">
            <a:extLst>
              <a:ext uri="{FF2B5EF4-FFF2-40B4-BE49-F238E27FC236}">
                <a16:creationId xmlns:a16="http://schemas.microsoft.com/office/drawing/2014/main" id="{9135F88D-79A5-4D54-292B-0FA11A31E70A}"/>
              </a:ext>
            </a:extLst>
          </p:cNvPr>
          <p:cNvSpPr/>
          <p:nvPr/>
        </p:nvSpPr>
        <p:spPr>
          <a:xfrm>
            <a:off x="4743449" y="5576924"/>
            <a:ext cx="2202872" cy="922506"/>
          </a:xfrm>
          <a:prstGeom prst="roundRect">
            <a:avLst/>
          </a:prstGeom>
          <a:solidFill>
            <a:srgbClr val="0070C0"/>
          </a:solidFill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B12EC7D3-3333-C218-1671-4072E261E499}"/>
              </a:ext>
            </a:extLst>
          </p:cNvPr>
          <p:cNvCxnSpPr>
            <a:cxnSpLocks/>
          </p:cNvCxnSpPr>
          <p:nvPr/>
        </p:nvCxnSpPr>
        <p:spPr>
          <a:xfrm>
            <a:off x="5836227" y="5101936"/>
            <a:ext cx="1922317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Rectangle: Rounded Corners 43">
            <a:extLst>
              <a:ext uri="{FF2B5EF4-FFF2-40B4-BE49-F238E27FC236}">
                <a16:creationId xmlns:a16="http://schemas.microsoft.com/office/drawing/2014/main" id="{23987117-33EC-1ADC-49C9-081293690BC2}"/>
              </a:ext>
            </a:extLst>
          </p:cNvPr>
          <p:cNvSpPr/>
          <p:nvPr/>
        </p:nvSpPr>
        <p:spPr>
          <a:xfrm>
            <a:off x="7758544" y="4673011"/>
            <a:ext cx="3595243" cy="922506"/>
          </a:xfrm>
          <a:prstGeom prst="roundRect">
            <a:avLst/>
          </a:prstGeom>
          <a:solidFill>
            <a:schemeClr val="bg1"/>
          </a:solidFill>
          <a:ln w="381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516277FC-7A7C-FFBB-2ED4-51C95E342BCC}"/>
              </a:ext>
            </a:extLst>
          </p:cNvPr>
          <p:cNvSpPr txBox="1"/>
          <p:nvPr/>
        </p:nvSpPr>
        <p:spPr>
          <a:xfrm>
            <a:off x="7862456" y="4719166"/>
            <a:ext cx="333202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u="sng" dirty="0"/>
              <a:t>Excluded cases (n=125):</a:t>
            </a:r>
          </a:p>
          <a:p>
            <a:r>
              <a:rPr lang="en-US" sz="1400" dirty="0"/>
              <a:t>Uncontactable by phone therefore nurse did not follow up</a:t>
            </a:r>
          </a:p>
          <a:p>
            <a:endParaRPr lang="en-US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9DE6152-3ABC-ABE5-49C6-AB5073642153}"/>
              </a:ext>
            </a:extLst>
          </p:cNvPr>
          <p:cNvSpPr txBox="1"/>
          <p:nvPr/>
        </p:nvSpPr>
        <p:spPr>
          <a:xfrm>
            <a:off x="4949538" y="5618288"/>
            <a:ext cx="172489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chemeClr val="bg1"/>
                </a:solidFill>
              </a:rPr>
              <a:t>Individuals who were followed up for 6 months (n=528)</a:t>
            </a:r>
          </a:p>
        </p:txBody>
      </p:sp>
    </p:spTree>
    <p:extLst>
      <p:ext uri="{BB962C8B-B14F-4D97-AF65-F5344CB8AC3E}">
        <p14:creationId xmlns:p14="http://schemas.microsoft.com/office/powerpoint/2010/main" val="3113856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8</Words>
  <Application>Microsoft Office PowerPoint</Application>
  <PresentationFormat>Widescreen</PresentationFormat>
  <Paragraphs>1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Fira Sans</vt:lpstr>
      <vt:lpstr>Office Theme</vt:lpstr>
      <vt:lpstr>Participant selec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rticipant selection</dc:title>
  <dc:creator>Sungwon Yoon</dc:creator>
  <cp:lastModifiedBy>Sungwon Yoon</cp:lastModifiedBy>
  <cp:revision>2</cp:revision>
  <dcterms:created xsi:type="dcterms:W3CDTF">2023-09-30T14:35:02Z</dcterms:created>
  <dcterms:modified xsi:type="dcterms:W3CDTF">2023-10-03T13:55:51Z</dcterms:modified>
</cp:coreProperties>
</file>